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2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80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epesh\AppData\Local\Temp\00ed5552-c4f4-488d-b8da-3be0f4e06a32_652d1b97066c6-MegaSSR_Results.zip.a32\The%20distribution%20of%20the%20different%20SSR%20classes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100" baseline="0">
                <a:solidFill>
                  <a:schemeClr val="lt1">
                    <a:lumMod val="95000"/>
                  </a:schemeClr>
                </a:solidFill>
                <a:effectLst>
                  <a:outerShdw blurRad="50800" dist="38100" dir="5400000" algn="t" rotWithShape="0">
                    <a:prstClr val="black">
                      <a:alpha val="40000"/>
                    </a:prstClr>
                  </a:outerShdw>
                </a:effectLst>
                <a:latin typeface="+mn-lt"/>
                <a:ea typeface="+mn-ea"/>
                <a:cs typeface="+mn-cs"/>
              </a:defRPr>
            </a:pPr>
            <a:r>
              <a:rPr lang="en-IN"/>
              <a:t>RiceMetaSys Gene SSR Distrib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100" baseline="0">
              <a:solidFill>
                <a:schemeClr val="lt1">
                  <a:lumMod val="95000"/>
                </a:schemeClr>
              </a:solidFill>
              <a:effectLst>
                <a:outerShdw blurRad="50800" dist="38100" dir="5400000" algn="t" rotWithShape="0">
                  <a:prstClr val="black">
                    <a:alpha val="40000"/>
                  </a:prstClr>
                </a:outerShdw>
              </a:effectLst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he distribution of the differe'!$D$1</c:f>
              <c:strCache>
                <c:ptCount val="1"/>
                <c:pt idx="0">
                  <c:v>Total No. of present</c:v>
                </c:pt>
              </c:strCache>
            </c:strRef>
          </c:tx>
          <c:spPr>
            <a:gradFill rotWithShape="1">
              <a:gsLst>
                <a:gs pos="0">
                  <a:schemeClr val="accent6">
                    <a:satMod val="103000"/>
                    <a:lumMod val="102000"/>
                    <a:tint val="94000"/>
                  </a:schemeClr>
                </a:gs>
                <a:gs pos="50000">
                  <a:schemeClr val="accent6">
                    <a:satMod val="110000"/>
                    <a:lumMod val="100000"/>
                    <a:shade val="100000"/>
                  </a:schemeClr>
                </a:gs>
                <a:gs pos="100000">
                  <a:schemeClr val="accent6"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>
              <a:outerShdw blurRad="57150" dist="19050" dir="5400000" algn="ctr" rotWithShape="0">
                <a:srgbClr val="000000">
                  <a:alpha val="63000"/>
                </a:srgbClr>
              </a:outerShdw>
            </a:effectLst>
          </c:spPr>
          <c:invertIfNegative val="0"/>
          <c:cat>
            <c:strRef>
              <c:f>'The distribution of the differe'!$C$2:$C$6</c:f>
              <c:strCache>
                <c:ptCount val="5"/>
                <c:pt idx="0">
                  <c:v>Di</c:v>
                </c:pt>
                <c:pt idx="1">
                  <c:v>Tri</c:v>
                </c:pt>
                <c:pt idx="2">
                  <c:v>Tetra</c:v>
                </c:pt>
                <c:pt idx="3">
                  <c:v>Penta</c:v>
                </c:pt>
                <c:pt idx="4">
                  <c:v>Hexa</c:v>
                </c:pt>
              </c:strCache>
            </c:strRef>
          </c:cat>
          <c:val>
            <c:numRef>
              <c:f>'The distribution of the differe'!$D$2:$D$6</c:f>
              <c:numCache>
                <c:formatCode>General</c:formatCode>
                <c:ptCount val="5"/>
                <c:pt idx="0">
                  <c:v>2012</c:v>
                </c:pt>
                <c:pt idx="1">
                  <c:v>5135</c:v>
                </c:pt>
                <c:pt idx="2">
                  <c:v>677</c:v>
                </c:pt>
                <c:pt idx="3">
                  <c:v>1118</c:v>
                </c:pt>
                <c:pt idx="4">
                  <c:v>10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AF4-4F6A-87A5-7668BA0666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1167346847"/>
        <c:axId val="1254169599"/>
      </c:barChart>
      <c:catAx>
        <c:axId val="116734684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all" baseline="0">
                    <a:solidFill>
                      <a:schemeClr val="lt1">
                        <a:lumMod val="8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 Motif repeats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all" baseline="0">
                  <a:solidFill>
                    <a:schemeClr val="lt1">
                      <a:lumMod val="8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lt1">
                <a:lumMod val="95000"/>
                <a:alpha val="54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lt1">
                    <a:lumMod val="8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54169599"/>
        <c:crosses val="autoZero"/>
        <c:auto val="1"/>
        <c:lblAlgn val="ctr"/>
        <c:lblOffset val="100"/>
        <c:noMultiLvlLbl val="0"/>
      </c:catAx>
      <c:valAx>
        <c:axId val="125416959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cap="all" baseline="0">
                    <a:solidFill>
                      <a:schemeClr val="lt1">
                        <a:lumMod val="8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Motif repeat numbe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cap="all" baseline="0">
                  <a:solidFill>
                    <a:schemeClr val="lt1">
                      <a:lumMod val="8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lt1">
                    <a:lumMod val="8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6734684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gradFill flip="none" rotWithShape="1">
      <a:gsLst>
        <a:gs pos="0">
          <a:schemeClr val="dk1">
            <a:lumMod val="65000"/>
            <a:lumOff val="35000"/>
          </a:schemeClr>
        </a:gs>
        <a:gs pos="100000">
          <a:schemeClr val="dk1">
            <a:lumMod val="85000"/>
            <a:lumOff val="15000"/>
          </a:schemeClr>
        </a:gs>
      </a:gsLst>
      <a:path path="circle">
        <a:fillToRect l="50000" t="50000" r="50000" b="50000"/>
      </a:path>
      <a:tileRect/>
    </a:gradFill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9">
  <cs:axisTitle>
    <cs:lnRef idx="0"/>
    <cs:fillRef idx="0"/>
    <cs:effectRef idx="0"/>
    <cs:fontRef idx="minor">
      <a:schemeClr val="lt1">
        <a:lumMod val="85000"/>
      </a:schemeClr>
    </cs:fontRef>
    <cs:defRPr sz="900" b="1" kern="1200" cap="all"/>
  </cs:axisTitle>
  <cs:categoryAxis>
    <cs:lnRef idx="0"/>
    <cs:fillRef idx="0"/>
    <cs:effectRef idx="0"/>
    <cs:fontRef idx="minor">
      <a:schemeClr val="lt1">
        <a:lumMod val="85000"/>
      </a:schemeClr>
    </cs:fontRef>
    <cs:spPr>
      <a:ln w="12700" cap="flat" cmpd="sng" algn="ctr">
        <a:solidFill>
          <a:schemeClr val="lt1">
            <a:lumMod val="95000"/>
            <a:alpha val="54000"/>
          </a:schemeClr>
        </a:solidFill>
        <a:round/>
      </a:ln>
    </cs:spPr>
    <cs:defRPr sz="900" kern="120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dk1">
              <a:lumMod val="65000"/>
              <a:lumOff val="35000"/>
            </a:schemeClr>
          </a:gs>
          <a:gs pos="100000">
            <a:schemeClr val="dk1">
              <a:lumMod val="85000"/>
              <a:lumOff val="15000"/>
            </a:schemeClr>
          </a:gs>
        </a:gsLst>
        <a:path path="circle">
          <a:fillToRect l="50000" t="50000" r="50000" b="50000"/>
        </a:path>
        <a:tileRect/>
      </a:gradFill>
    </cs:spPr>
    <cs:defRPr sz="1000" kern="1200"/>
  </cs:chartArea>
  <cs:dataLabel>
    <cs:lnRef idx="0"/>
    <cs:fillRef idx="0"/>
    <cs:effectRef idx="0"/>
    <cs:fontRef idx="minor">
      <a:schemeClr val="lt1">
        <a:lumMod val="8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lt1"/>
    </cs:fontRef>
  </cs:dataPoint>
  <cs:dataPoint3D>
    <cs:lnRef idx="0"/>
    <cs:fillRef idx="3">
      <cs:styleClr val="auto"/>
    </cs:fillRef>
    <cs:effectRef idx="3"/>
    <cs:fontRef idx="minor">
      <a:schemeClr val="lt1"/>
    </cs:fontRef>
  </cs:dataPoint3D>
  <cs:dataPointLine>
    <cs:lnRef idx="0">
      <cs:styleClr val="auto"/>
    </cs:lnRef>
    <cs:fillRef idx="3"/>
    <cs:effectRef idx="3"/>
    <cs:fontRef idx="minor">
      <a:schemeClr val="lt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lt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lt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lt1">
        <a:lumMod val="85000"/>
      </a:schemeClr>
    </cs:fontRef>
    <cs:spPr>
      <a:ln w="9525">
        <a:solidFill>
          <a:schemeClr val="lt1">
            <a:lumMod val="95000"/>
            <a:alpha val="54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lt1"/>
    </cs:fontRef>
    <cs:spPr>
      <a:solidFill>
        <a:schemeClr val="dk1">
          <a:lumMod val="75000"/>
          <a:lumOff val="25000"/>
        </a:schemeClr>
      </a:solidFill>
      <a:ln w="9525">
        <a:solidFill>
          <a:schemeClr val="lt1">
            <a:lumMod val="95000"/>
            <a:alpha val="54000"/>
          </a:schemeClr>
        </a:solidFill>
      </a:ln>
    </cs:spPr>
  </cs:downBar>
  <cs:dropLine>
    <cs:lnRef idx="0"/>
    <cs:fillRef idx="0"/>
    <cs:effectRef idx="0"/>
    <cs:fontRef idx="minor">
      <a:schemeClr val="lt1"/>
    </cs:fontRef>
    <cs:spPr>
      <a:ln w="9525">
        <a:solidFill>
          <a:schemeClr val="lt1">
            <a:lumMod val="95000"/>
            <a:alpha val="54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lt1"/>
    </cs:fontRef>
    <cs:spPr>
      <a:ln w="9525" cap="flat" cmpd="sng" algn="ctr">
        <a:solidFill>
          <a:schemeClr val="lt1">
            <a:lumMod val="9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lt1"/>
    </cs:fontRef>
    <cs:spPr>
      <a:ln w="9525" cap="flat" cmpd="sng" algn="ctr">
        <a:solidFill>
          <a:schemeClr val="lt1">
            <a:lumMod val="95000"/>
            <a:alpha val="10000"/>
          </a:schemeClr>
        </a:solidFill>
        <a:round/>
      </a:ln>
    </cs:spPr>
  </cs:gridlineMajor>
  <cs:gridlineMinor>
    <cs:lnRef idx="0"/>
    <cs:fillRef idx="0"/>
    <cs:effectRef idx="0"/>
    <cs:fontRef idx="minor">
      <a:schemeClr val="lt1"/>
    </cs:fontRef>
    <cs:spPr>
      <a:ln>
        <a:solidFill>
          <a:schemeClr val="lt1">
            <a:lumMod val="95000"/>
            <a:alpha val="5000"/>
          </a:schemeClr>
        </a:solidFill>
      </a:ln>
    </cs:spPr>
  </cs:gridlineMinor>
  <cs:hiLoLine>
    <cs:lnRef idx="0"/>
    <cs:fillRef idx="0"/>
    <cs:effectRef idx="0"/>
    <cs:fontRef idx="minor">
      <a:schemeClr val="lt1"/>
    </cs:fontRef>
    <cs:spPr>
      <a:ln w="9525">
        <a:solidFill>
          <a:schemeClr val="lt1">
            <a:lumMod val="95000"/>
            <a:alpha val="54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lt1"/>
    </cs:fontRef>
    <cs:spPr>
      <a:ln w="9525">
        <a:solidFill>
          <a:schemeClr val="lt1">
            <a:lumMod val="95000"/>
            <a:alpha val="54000"/>
          </a:schemeClr>
        </a:solidFill>
      </a:ln>
    </cs:spPr>
  </cs:leaderLine>
  <cs:legend>
    <cs:lnRef idx="0"/>
    <cs:fillRef idx="0"/>
    <cs:effectRef idx="0"/>
    <cs:fontRef idx="minor">
      <a:schemeClr val="lt1">
        <a:lumMod val="8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lt1">
        <a:lumMod val="85000"/>
      </a:schemeClr>
    </cs:fontRef>
    <cs:spPr>
      <a:ln w="12700" cap="flat" cmpd="sng" algn="ctr">
        <a:solidFill>
          <a:schemeClr val="lt1">
            <a:lumMod val="95000"/>
            <a:alpha val="54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lt1"/>
    </cs:fontRef>
    <cs:spPr>
      <a:ln w="9525" cap="flat" cmpd="sng" algn="ctr">
        <a:solidFill>
          <a:schemeClr val="lt1">
            <a:lumMod val="95000"/>
            <a:alpha val="54000"/>
          </a:schemeClr>
        </a:solidFill>
        <a:round/>
      </a:ln>
    </cs:spPr>
  </cs:seriesLine>
  <cs:title>
    <cs:lnRef idx="0"/>
    <cs:fillRef idx="0"/>
    <cs:effectRef idx="0"/>
    <cs:fontRef idx="minor">
      <a:schemeClr val="lt1">
        <a:lumMod val="95000"/>
      </a:schemeClr>
    </cs:fontRef>
    <cs:defRPr sz="1600" b="1" kern="1200" spc="100" baseline="0">
      <a:effectLst>
        <a:outerShdw blurRad="50800" dist="38100" dir="5400000" algn="t" rotWithShape="0">
          <a:prstClr val="black">
            <a:alpha val="40000"/>
          </a:prstClr>
        </a:outerShdw>
      </a:effectLst>
    </cs:defRPr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lt1">
        <a:lumMod val="85000"/>
      </a:schemeClr>
    </cs:fontRef>
    <cs:defRPr sz="900" kern="1200"/>
  </cs:trendlineLabel>
  <cs:upBar>
    <cs:lnRef idx="0"/>
    <cs:fillRef idx="0"/>
    <cs:effectRef idx="0"/>
    <cs:fontRef idx="minor">
      <a:schemeClr val="lt1"/>
    </cs:fontRef>
    <cs:spPr>
      <a:solidFill>
        <a:schemeClr val="lt1"/>
      </a:solidFill>
      <a:ln w="9525">
        <a:solidFill>
          <a:schemeClr val="lt1">
            <a:lumMod val="95000"/>
            <a:alpha val="54000"/>
          </a:schemeClr>
        </a:solidFill>
      </a:ln>
    </cs:spPr>
  </cs:upBar>
  <cs:valueAxis>
    <cs:lnRef idx="0"/>
    <cs:fillRef idx="0"/>
    <cs:effectRef idx="0"/>
    <cs:fontRef idx="minor">
      <a:schemeClr val="lt1">
        <a:lumMod val="8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CC8579-A211-366A-A12C-6D05E35A9F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EBA23F5-3BDC-9937-4F5D-3AF25FD88F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8F8C12-741E-E025-7272-60609CACB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B0001E-7A95-9C3D-420E-BA0E2CFED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3D9339-76A7-4CC5-DC28-E2E17C7C7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6716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B73C7-ADA5-516B-5C2C-ECF4C9525C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81F117-06A5-C4D1-14D0-4B21117CF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5A8691-E06C-9BB5-A5AD-D3F639A35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56096E-BAFE-188F-5480-049618DC1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AEC642-79ED-1BA4-D730-95A3B349B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9925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753289-91BD-3530-3B54-BC6EFA0C3F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6404E3-1011-F467-DEC5-175501BCAE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28680E-1322-6486-6265-14942200E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B3A993-C06D-ABAF-06D0-7D67B817A2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A521CF-1AF4-E983-10D7-3911A69D6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3407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67D8BC-EBBB-9582-12BD-B839413772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CA3F1B-BD3D-2A82-1BB7-B42E56C75A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64E5B4-EAE1-D2FE-6A05-EA4B9FAE5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CB3F2-FCB5-4931-E119-9FC1666C9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E3838D-53CC-0FC1-19C2-24B3D8B21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55041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80C459-F9FC-1231-DF80-7AEDD1E4A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683956-A047-976F-9B74-15F5947BF8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B475D9-FC6C-FD16-5EC7-0991F5EFC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3C0F0F-CBA9-7D0E-7C62-AC54C58AB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4E8EA0-FDA8-F5E2-1CC6-C90D99416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8926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E4B63B-A69F-BE96-3455-9ADF4840F2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11D688-5B81-3464-BD90-EF7551F58D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541BC0-0A8F-5496-EA33-5A39779F62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FC4240-5980-5AA4-FB97-781A59D62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311D6E-D7A5-7272-53E9-DCF0868F2A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824C65-4375-9CE6-BE60-1CB991685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4010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65E52-77B2-AF2B-1545-BBA0BC7CA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74F26C-78B3-C6C4-2B52-BE6347972B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5DA3D8-6366-ACE6-E035-DE0B313918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EDBA53-A21F-A57B-5084-2F4934D78C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CDD553-2ECA-39EA-5CAA-D67C2C6FD6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F7D80A-1DFD-FB3F-1BAA-3E43C1CF3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293A95-3F5F-E7C7-B2EA-750666BCC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6D52E80-CA46-4CF8-2C8F-D9DA0022B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2041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C7A330-9DEF-F090-8010-710F80BD76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D0B38A-8E44-A910-8847-CD97F4790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39EF66-3A25-56DB-CE1C-31A232C79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EBE2015-6647-D16C-316F-851C27DFD6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1431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4A1DA2-693F-C1B2-16E9-8CAA0527D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52EFD0-93E9-FCB5-FA13-112ED9380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2E3134-BBCD-DAB3-62A0-19497B492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8182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863CE5-760E-2F88-9B42-5444B737B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A1AAEE-07E3-1082-8CE5-C3AD4F3A70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700A20-A82D-C1FE-85D8-4A2D424269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88BDDA-36CF-2491-A31C-FFE93788E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0733B4-B135-DDDA-65D4-3AF4C670A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D598D3-9010-DBAA-0525-C03611AB9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93245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BF0DE3-0779-1202-82D4-D3399BD09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12B996-A44E-4C37-4630-EC7EF13DB5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09D8E0-9E23-3D5F-91BA-A45FDD38CA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1F1325-6577-14D0-D942-AA5FBDC79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16E36F-8FAF-7DE0-D6A8-FEA4C7CF2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0B599E-E4FD-3A8C-98B8-6FDD01180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9971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677F76-ECAF-8BFB-8901-64BA1E4E8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1DC277-7B4D-BFEB-4CB3-86E0D5B605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89F3F2-EC62-DB71-992F-C6736E49C2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3F3E2E-54E3-4E9A-85AB-A75F341BB174}" type="datetimeFigureOut">
              <a:rPr lang="en-IN" smtClean="0"/>
              <a:t>13-05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BD0F0-12B6-AD7F-67C1-3AB0F8928E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76222E-5EFA-44D1-55C6-33011EDDF3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30F50-08E4-4A12-B0AA-AED4B8653EF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2725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005C9F7-5C9E-BEF8-EAC1-2E7C8BDF30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8326" y="92466"/>
            <a:ext cx="4135349" cy="4135349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4633193-6391-6F1E-B894-6C443CDFB312}"/>
              </a:ext>
            </a:extLst>
          </p:cNvPr>
          <p:cNvSpPr txBox="1"/>
          <p:nvPr/>
        </p:nvSpPr>
        <p:spPr>
          <a:xfrm>
            <a:off x="1302795" y="4548024"/>
            <a:ext cx="11108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Comparision of detected known miRNA from both tools in all the datasets 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40926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58A980C-B4B8-58B2-544A-DDDE13FB14E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48" t="1363" r="3072"/>
          <a:stretch/>
        </p:blipFill>
        <p:spPr>
          <a:xfrm>
            <a:off x="297949" y="205482"/>
            <a:ext cx="5580964" cy="5578869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42A6FD0-3296-10DB-A43D-90CB0A93545A}"/>
              </a:ext>
            </a:extLst>
          </p:cNvPr>
          <p:cNvSpPr txBox="1"/>
          <p:nvPr/>
        </p:nvSpPr>
        <p:spPr>
          <a:xfrm>
            <a:off x="634974" y="5791197"/>
            <a:ext cx="111083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In-silico expression analysis of identified hub genes colocalized in the meta-QTL region : A ; In-silico expression analysis of identified hub genes colocalized in the meta-QTL region in response to various hormones in Root: B; In-silico expression analysis of identified hub genes colocalized in the meta-QTL region in response to various hormones in Shoot</a:t>
            </a:r>
            <a:endParaRPr lang="en-IN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F943D03-3A1C-D314-0D42-96260583E4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05482"/>
            <a:ext cx="5883667" cy="5578868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0BDDF6C-2131-70E9-80E6-10463D064860}"/>
              </a:ext>
            </a:extLst>
          </p:cNvPr>
          <p:cNvSpPr txBox="1"/>
          <p:nvPr/>
        </p:nvSpPr>
        <p:spPr>
          <a:xfrm>
            <a:off x="295928" y="210619"/>
            <a:ext cx="339047" cy="369332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IN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587350-DDE4-955B-F072-0C3C3C4E16DE}"/>
              </a:ext>
            </a:extLst>
          </p:cNvPr>
          <p:cNvSpPr txBox="1"/>
          <p:nvPr/>
        </p:nvSpPr>
        <p:spPr>
          <a:xfrm>
            <a:off x="6088856" y="198635"/>
            <a:ext cx="339047" cy="369332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IN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28794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CE85F101-A627-59D4-7338-4CA06821B4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5639771"/>
              </p:ext>
            </p:extLst>
          </p:nvPr>
        </p:nvGraphicFramePr>
        <p:xfrm>
          <a:off x="316786" y="259422"/>
          <a:ext cx="4572000" cy="3018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E67438D-ACD6-FE8B-0A14-89C46C943102}"/>
              </a:ext>
            </a:extLst>
          </p:cNvPr>
          <p:cNvSpPr txBox="1"/>
          <p:nvPr/>
        </p:nvSpPr>
        <p:spPr>
          <a:xfrm>
            <a:off x="316786" y="4352815"/>
            <a:ext cx="11108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Figure 3: </a:t>
            </a:r>
            <a:r>
              <a:rPr lang="en-IN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repeat distribution of SSR specific to drought responsive genes in rice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3732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</TotalTime>
  <Words>104</Words>
  <Application>Microsoft Office PowerPoint</Application>
  <PresentationFormat>Widescreen</PresentationFormat>
  <Paragraphs>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ESH JAISWAL</dc:creator>
  <cp:lastModifiedBy>DEEPESH JAISWAL</cp:lastModifiedBy>
  <cp:revision>9</cp:revision>
  <dcterms:created xsi:type="dcterms:W3CDTF">2024-01-30T18:08:47Z</dcterms:created>
  <dcterms:modified xsi:type="dcterms:W3CDTF">2024-05-13T10:56:57Z</dcterms:modified>
</cp:coreProperties>
</file>